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668" y="13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4/5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0"/>
          <p:cNvSpPr txBox="1"/>
          <p:nvPr/>
        </p:nvSpPr>
        <p:spPr>
          <a:xfrm>
            <a:off x="404664" y="683568"/>
            <a:ext cx="4517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F</a:t>
            </a:r>
            <a:endParaRPr lang="zh-CN" altLang="en-US" sz="2400" dirty="0"/>
          </a:p>
        </p:txBody>
      </p:sp>
      <p:pic>
        <p:nvPicPr>
          <p:cNvPr id="4" name="Picture 3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5529" y="1282898"/>
            <a:ext cx="4998138" cy="312724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5" name="Picture 4"/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5529" y="1714993"/>
            <a:ext cx="4998138" cy="312724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 rot="18780000">
            <a:off x="811905" y="2465307"/>
            <a:ext cx="9434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 smtClean="0">
                <a:latin typeface="Arial" pitchFamily="34" charset="0"/>
              </a:rPr>
              <a:t>Blank</a:t>
            </a:r>
            <a:endParaRPr lang="zh-CN" altLang="en-US" sz="1200" dirty="0">
              <a:latin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8780000">
            <a:off x="191114" y="3017299"/>
            <a:ext cx="2433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 err="1" smtClean="0">
                <a:latin typeface="Arial" pitchFamily="34" charset="0"/>
              </a:rPr>
              <a:t>Transfection</a:t>
            </a:r>
            <a:r>
              <a:rPr lang="en-US" altLang="zh-CN" sz="1200" dirty="0" smtClean="0">
                <a:latin typeface="Arial" pitchFamily="34" charset="0"/>
              </a:rPr>
              <a:t> Reagent</a:t>
            </a:r>
            <a:endParaRPr lang="zh-CN" altLang="en-US" sz="1200" dirty="0">
              <a:latin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8780000">
            <a:off x="1814713" y="2585919"/>
            <a:ext cx="12477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 smtClean="0">
                <a:latin typeface="Arial" pitchFamily="34" charset="0"/>
              </a:rPr>
              <a:t>pcDNA3.0</a:t>
            </a:r>
            <a:endParaRPr lang="zh-CN" altLang="en-US" sz="1200" dirty="0">
              <a:latin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8780000">
            <a:off x="1503594" y="3002573"/>
            <a:ext cx="238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 smtClean="0">
                <a:latin typeface="Arial" pitchFamily="34" charset="0"/>
              </a:rPr>
              <a:t>pcDNA3.0-miR-130</a:t>
            </a:r>
            <a:endParaRPr lang="zh-CN" altLang="en-US" sz="1200" dirty="0">
              <a:latin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8780000">
            <a:off x="2136786" y="2994899"/>
            <a:ext cx="238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 smtClean="0">
                <a:latin typeface="Arial" pitchFamily="34" charset="0"/>
              </a:rPr>
              <a:t>pcDNA3.0-miR-301a</a:t>
            </a:r>
            <a:endParaRPr lang="zh-CN" altLang="en-US" sz="1200" dirty="0">
              <a:latin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8780000">
            <a:off x="2918940" y="2925727"/>
            <a:ext cx="21770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 smtClean="0">
                <a:latin typeface="Arial" pitchFamily="34" charset="0"/>
              </a:rPr>
              <a:t>pcDNA3.0-miR-302</a:t>
            </a:r>
            <a:endParaRPr lang="zh-CN" altLang="en-US" sz="1200" dirty="0">
              <a:latin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8780000">
            <a:off x="3569435" y="2921075"/>
            <a:ext cx="21642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 smtClean="0">
                <a:latin typeface="Arial" pitchFamily="34" charset="0"/>
              </a:rPr>
              <a:t>pcDNA3.0-miR-454-3p</a:t>
            </a:r>
            <a:endParaRPr lang="zh-CN" altLang="en-US" sz="1200" dirty="0">
              <a:latin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8780000">
            <a:off x="4190770" y="2921179"/>
            <a:ext cx="21454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 smtClean="0">
                <a:latin typeface="Arial" pitchFamily="34" charset="0"/>
              </a:rPr>
              <a:t>pcDNA3.0-miR-19b</a:t>
            </a:r>
            <a:endParaRPr lang="zh-CN" altLang="en-US" sz="1200" dirty="0">
              <a:latin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10318" y="1285607"/>
            <a:ext cx="9035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BTG1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10318" y="1714992"/>
            <a:ext cx="1112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GAPDH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386871" y="950471"/>
            <a:ext cx="26306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86-O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接连接符 16"/>
          <p:cNvCxnSpPr/>
          <p:nvPr/>
        </p:nvCxnSpPr>
        <p:spPr>
          <a:xfrm>
            <a:off x="1233924" y="2252260"/>
            <a:ext cx="488370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511344" y="2004323"/>
            <a:ext cx="534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Fold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237966" y="2020328"/>
            <a:ext cx="51433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0.98         1.00        1.35        0.32        1.07       1.15        0.32       0.24</a:t>
            </a:r>
          </a:p>
        </p:txBody>
      </p:sp>
    </p:spTree>
    <p:extLst>
      <p:ext uri="{BB962C8B-B14F-4D97-AF65-F5344CB8AC3E}">
        <p14:creationId xmlns:p14="http://schemas.microsoft.com/office/powerpoint/2010/main" val="36713540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2</TotalTime>
  <Words>22</Words>
  <Application>Microsoft Office PowerPoint</Application>
  <PresentationFormat>全屏显示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uxin</dc:creator>
  <cp:lastModifiedBy>wuxin</cp:lastModifiedBy>
  <cp:revision>26</cp:revision>
  <dcterms:created xsi:type="dcterms:W3CDTF">2014-01-18T10:15:54Z</dcterms:created>
  <dcterms:modified xsi:type="dcterms:W3CDTF">2014-05-19T15:17:21Z</dcterms:modified>
</cp:coreProperties>
</file>